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434" r:id="rId2"/>
    <p:sldId id="443" r:id="rId3"/>
    <p:sldId id="444" r:id="rId4"/>
    <p:sldId id="447" r:id="rId5"/>
    <p:sldId id="448" r:id="rId6"/>
    <p:sldId id="449" r:id="rId7"/>
    <p:sldId id="450" r:id="rId8"/>
    <p:sldId id="451" r:id="rId9"/>
    <p:sldId id="446" r:id="rId10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452" autoAdjust="0"/>
  </p:normalViewPr>
  <p:slideViewPr>
    <p:cSldViewPr snapToGrid="0">
      <p:cViewPr varScale="1">
        <p:scale>
          <a:sx n="117" d="100"/>
          <a:sy n="117" d="100"/>
        </p:scale>
        <p:origin x="3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B4267E2-D66B-442B-8815-D5BF5CD32074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4EF1BE17-E305-40EF-B3ED-BCE414B4A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16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F1BE17-E305-40EF-B3ED-BCE414B4A4F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5792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0DC872-5FC6-6A1A-1F38-527A535E83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9E5DB4-4C70-DB3A-2058-550A4D3B54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9C80F9-F2B6-8BBF-8E7B-69BD853FA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990DED-EFBA-743C-DF57-4C42FDDA5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E31EBB-3B00-A937-A363-9959B97AD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507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4BE7E-BC3C-2430-6DED-F6E2E3705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4388B9-36E6-5F95-F1DC-0DF8F9A548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163EFC-685E-EC67-7C86-B23D1EF81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D89A47-52C4-2AF1-D4B3-97EDC3725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0B875D-C5D9-4633-834A-051FE801F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838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239CD4-3734-A003-6CE6-AF16E326B7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E78552-A684-FDB8-1D8A-29852929DE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D7A10-4497-D970-CD6C-202789F7C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82563-8CCD-7C4F-817F-31EE5430B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6F052A-12D0-5D85-5D7B-C01199594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229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5615F-2FAD-50D6-E97B-19F21AF8AA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7C0AB7-D351-AAE9-A2D9-51FC5D40AE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789C1-C848-9BD8-646B-48050744B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A12C4-8A4F-0F24-AE1B-CF3757AFA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1023D9-0524-6627-715D-9B541EE26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055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48754-1BAE-AA89-36D5-E59A0BC2B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A7EC9A-1BDB-E971-4209-E0A586D1A1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26192B-8C14-E13D-D761-8A34B70BE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99C167-AF45-1EC6-0741-BFF0114F3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4C7FB-1CF6-5222-4AE7-121A13CE2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781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2BBCB-862D-CA46-6EE2-6698509B94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85E1B5-B139-9C1B-2F5F-3C3D9A1C27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693E87-0177-0E48-8F8B-DDF7BA4032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09CCB3-ED86-D2C0-F73C-4738BB812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A3FC21-B20A-EA38-BC65-FE90BF758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CF48E1-658B-6A59-4F9E-E2B6DACAE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778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6F952-8BBA-E843-A6FA-18797A1AF8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AD76F2-3DD0-627E-3DE3-5908DC1309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6A81BF-6043-AA72-B9AA-8EA599BDF0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18F2F3-77A6-D68F-584C-0687B1789F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44BB0C-A5C1-5516-CD8D-BB5B08499A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4B70D1-9B7B-B666-06B2-40970CC41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D85FF5-49C9-0F97-BEA8-5AEE5A776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76434B-FA87-211D-987D-606DE8DEF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468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40BB9-16B8-F0E1-EBFE-D2BED71CBE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032909-CFE3-1826-E6CE-421A32F96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26F3165-5E8E-EBD5-A17A-C8F5885FC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C1E586-DB21-8A57-9C13-CAAF44356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094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0C6B42-BC99-C834-F64B-AA42B2C08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24D232-0B24-EB44-836F-0616520FF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8C9328-6D29-EA03-E2A9-4944F045D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904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EBB93E-14C3-3D81-D3D0-52D12EA70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B25094-2C7F-07BF-7449-190C19AD31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5A47C8-B4A9-A634-C317-4C4CE019EF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EE9CF6-EC45-4DAA-042B-49C7BC36F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434A67-B406-5420-DDFA-9B5762E5B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88DB88-3C58-0B1F-70E8-1E1C61836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075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43709-012C-FFF2-F904-EF7FA205C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33BF64-9EA6-3FF0-4540-94C4E40B37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130C8A-34B8-E0B9-E293-D527D1FD90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D7577F-97EA-8635-DA85-83ED1AA06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A66F2D-153E-A586-974A-6F4D61666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B5D128-F055-CD91-A89D-E49E0687B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225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AF777C-6A74-3858-8F49-CFCF544A58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53AA1C-13D4-3A20-5917-BEE025BE7B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59B35D-C6F6-9A20-B47A-43AA6621C9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6B693-F66D-467C-877F-C5521EEB65C9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C8609D-B48B-D7D3-0A80-6161E39A57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F3DB0-893B-9C4E-678A-679BEF2E84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F9396-5024-4BDB-8AEB-42B784FE6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489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13" Type="http://schemas.openxmlformats.org/officeDocument/2006/relationships/image" Target="../media/image30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12" Type="http://schemas.openxmlformats.org/officeDocument/2006/relationships/image" Target="../media/image29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emf"/><Relationship Id="rId11" Type="http://schemas.openxmlformats.org/officeDocument/2006/relationships/image" Target="../media/image28.png"/><Relationship Id="rId5" Type="http://schemas.openxmlformats.org/officeDocument/2006/relationships/image" Target="../media/image22.emf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Relationship Id="rId14" Type="http://schemas.openxmlformats.org/officeDocument/2006/relationships/image" Target="../media/image3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13" Type="http://schemas.openxmlformats.org/officeDocument/2006/relationships/image" Target="../media/image43.emf"/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12" Type="http://schemas.openxmlformats.org/officeDocument/2006/relationships/image" Target="../media/image42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11" Type="http://schemas.openxmlformats.org/officeDocument/2006/relationships/image" Target="../media/image41.emf"/><Relationship Id="rId5" Type="http://schemas.openxmlformats.org/officeDocument/2006/relationships/image" Target="../media/image35.emf"/><Relationship Id="rId15" Type="http://schemas.openxmlformats.org/officeDocument/2006/relationships/image" Target="../media/image45.emf"/><Relationship Id="rId10" Type="http://schemas.openxmlformats.org/officeDocument/2006/relationships/image" Target="../media/image40.emf"/><Relationship Id="rId4" Type="http://schemas.openxmlformats.org/officeDocument/2006/relationships/image" Target="../media/image34.emf"/><Relationship Id="rId9" Type="http://schemas.openxmlformats.org/officeDocument/2006/relationships/image" Target="../media/image39.emf"/><Relationship Id="rId14" Type="http://schemas.openxmlformats.org/officeDocument/2006/relationships/image" Target="../media/image4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13" Type="http://schemas.openxmlformats.org/officeDocument/2006/relationships/image" Target="../media/image57.png"/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12" Type="http://schemas.openxmlformats.org/officeDocument/2006/relationships/image" Target="../media/image56.emf"/><Relationship Id="rId17" Type="http://schemas.openxmlformats.org/officeDocument/2006/relationships/image" Target="../media/image61.png"/><Relationship Id="rId2" Type="http://schemas.openxmlformats.org/officeDocument/2006/relationships/image" Target="../media/image46.emf"/><Relationship Id="rId16" Type="http://schemas.openxmlformats.org/officeDocument/2006/relationships/image" Target="../media/image6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emf"/><Relationship Id="rId11" Type="http://schemas.openxmlformats.org/officeDocument/2006/relationships/image" Target="../media/image55.emf"/><Relationship Id="rId5" Type="http://schemas.openxmlformats.org/officeDocument/2006/relationships/image" Target="../media/image49.emf"/><Relationship Id="rId15" Type="http://schemas.openxmlformats.org/officeDocument/2006/relationships/image" Target="../media/image59.png"/><Relationship Id="rId10" Type="http://schemas.openxmlformats.org/officeDocument/2006/relationships/image" Target="../media/image54.emf"/><Relationship Id="rId4" Type="http://schemas.openxmlformats.org/officeDocument/2006/relationships/image" Target="../media/image48.emf"/><Relationship Id="rId9" Type="http://schemas.openxmlformats.org/officeDocument/2006/relationships/image" Target="../media/image53.emf"/><Relationship Id="rId14" Type="http://schemas.openxmlformats.org/officeDocument/2006/relationships/image" Target="../media/image5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emf"/><Relationship Id="rId13" Type="http://schemas.openxmlformats.org/officeDocument/2006/relationships/image" Target="../media/image72.emf"/><Relationship Id="rId3" Type="http://schemas.openxmlformats.org/officeDocument/2006/relationships/image" Target="../media/image62.emf"/><Relationship Id="rId7" Type="http://schemas.openxmlformats.org/officeDocument/2006/relationships/image" Target="../media/image66.emf"/><Relationship Id="rId12" Type="http://schemas.openxmlformats.org/officeDocument/2006/relationships/image" Target="../media/image71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emf"/><Relationship Id="rId11" Type="http://schemas.openxmlformats.org/officeDocument/2006/relationships/image" Target="../media/image70.emf"/><Relationship Id="rId5" Type="http://schemas.openxmlformats.org/officeDocument/2006/relationships/image" Target="../media/image64.emf"/><Relationship Id="rId15" Type="http://schemas.openxmlformats.org/officeDocument/2006/relationships/image" Target="../media/image74.emf"/><Relationship Id="rId10" Type="http://schemas.openxmlformats.org/officeDocument/2006/relationships/image" Target="../media/image69.emf"/><Relationship Id="rId4" Type="http://schemas.openxmlformats.org/officeDocument/2006/relationships/image" Target="../media/image63.emf"/><Relationship Id="rId9" Type="http://schemas.openxmlformats.org/officeDocument/2006/relationships/image" Target="../media/image68.emf"/><Relationship Id="rId14" Type="http://schemas.openxmlformats.org/officeDocument/2006/relationships/image" Target="../media/image73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594F23D-AC74-10CB-EE0E-41E06FB71E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9675" y="1733550"/>
            <a:ext cx="2152650" cy="33909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B370509-534C-6D69-4625-A9E95AB19B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1722" y="1733550"/>
            <a:ext cx="2228850" cy="3390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3096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BF6488-C124-C63C-C6CC-C3D44A859125}"/>
              </a:ext>
            </a:extLst>
          </p:cNvPr>
          <p:cNvSpPr txBox="1"/>
          <p:nvPr/>
        </p:nvSpPr>
        <p:spPr>
          <a:xfrm>
            <a:off x="328862" y="3051197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uciniphil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E1CF5A9-2338-1123-ECB4-C6054EDD71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2113" y="2678759"/>
            <a:ext cx="1917325" cy="125400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5D27BA6-5D5B-3880-B5FE-7C2EC105FC6D}"/>
              </a:ext>
            </a:extLst>
          </p:cNvPr>
          <p:cNvSpPr txBox="1"/>
          <p:nvPr/>
        </p:nvSpPr>
        <p:spPr>
          <a:xfrm>
            <a:off x="1922237" y="2109535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olesce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0134BC-F496-FF7F-12DA-B736FCF57013}"/>
              </a:ext>
            </a:extLst>
          </p:cNvPr>
          <p:cNvSpPr txBox="1"/>
          <p:nvPr/>
        </p:nvSpPr>
        <p:spPr>
          <a:xfrm>
            <a:off x="4063858" y="2109536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ul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E39652-BA2E-02B7-E12F-25D17B49297F}"/>
              </a:ext>
            </a:extLst>
          </p:cNvPr>
          <p:cNvSpPr txBox="1"/>
          <p:nvPr/>
        </p:nvSpPr>
        <p:spPr>
          <a:xfrm>
            <a:off x="3117374" y="1708483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V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E9A9441-0A90-4708-5CC2-EC27E517E16C}"/>
              </a:ext>
            </a:extLst>
          </p:cNvPr>
          <p:cNvSpPr txBox="1"/>
          <p:nvPr/>
        </p:nvSpPr>
        <p:spPr>
          <a:xfrm>
            <a:off x="7122579" y="2109535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olesce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5C802A2-B1E6-318F-14A6-E1C7F2BB4FC0}"/>
              </a:ext>
            </a:extLst>
          </p:cNvPr>
          <p:cNvSpPr txBox="1"/>
          <p:nvPr/>
        </p:nvSpPr>
        <p:spPr>
          <a:xfrm>
            <a:off x="9332530" y="2109536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ul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79C8361-098D-0FF0-4C38-74D602C5FDD8}"/>
              </a:ext>
            </a:extLst>
          </p:cNvPr>
          <p:cNvSpPr txBox="1"/>
          <p:nvPr/>
        </p:nvSpPr>
        <p:spPr>
          <a:xfrm>
            <a:off x="8235551" y="170848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nt1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D3BCE1E-B3EC-2C03-4FEF-DC408DEC29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4236" y="2643273"/>
            <a:ext cx="1960901" cy="125400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3F38F25-FFD8-9AD5-1912-29CC95B5F1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46940" y="2643273"/>
            <a:ext cx="1966993" cy="128649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B68D977-BE0C-FEF7-DAEA-B8EBBF1699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79290" y="2643273"/>
            <a:ext cx="1960900" cy="1254008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617B4FC-6B58-C43B-73C8-FBAC4FFBD5B4}"/>
              </a:ext>
            </a:extLst>
          </p:cNvPr>
          <p:cNvCxnSpPr/>
          <p:nvPr/>
        </p:nvCxnSpPr>
        <p:spPr>
          <a:xfrm>
            <a:off x="1568116" y="2502568"/>
            <a:ext cx="9055768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204876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</a:p>
        </p:txBody>
      </p:sp>
      <p:pic>
        <p:nvPicPr>
          <p:cNvPr id="5" name="Picture 4" descr="A group of colorful boxes">
            <a:extLst>
              <a:ext uri="{FF2B5EF4-FFF2-40B4-BE49-F238E27FC236}">
                <a16:creationId xmlns:a16="http://schemas.microsoft.com/office/drawing/2014/main" id="{261FE54F-8C2F-BDD5-7F04-14316C9BAC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664" y="800099"/>
            <a:ext cx="7684008" cy="5816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3738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169016-D9DD-9B27-EFF4-8C11C35C3EEF}"/>
              </a:ext>
            </a:extLst>
          </p:cNvPr>
          <p:cNvSpPr txBox="1"/>
          <p:nvPr/>
        </p:nvSpPr>
        <p:spPr>
          <a:xfrm>
            <a:off x="80211" y="696237"/>
            <a:ext cx="1470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dolescent FV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836C6F9-4951-5B5E-A471-7864D96A7A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766" y="175175"/>
            <a:ext cx="2165460" cy="165690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6FC75A0-51A9-4ACD-FE7C-5783DB2904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9328" y="175175"/>
            <a:ext cx="2116245" cy="162956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80BDA3F-0753-FF67-CA29-5CE8A85677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19631" y="173486"/>
            <a:ext cx="2116245" cy="162956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7F5CEF7-A8C3-2F71-4758-6F01C0CD98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9766" y="1854120"/>
            <a:ext cx="2072498" cy="162956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26983CD-20F3-FC4D-5601-A8F0924B04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13860" y="1832079"/>
            <a:ext cx="2121713" cy="157488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9350394-E420-0EB5-195C-B50BA847B94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79674" y="1854120"/>
            <a:ext cx="2121713" cy="157488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D2BA43F2-1745-3DC4-DBE9-567B73D5CB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87892" y="3529390"/>
            <a:ext cx="2116245" cy="162956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A52ECB15-7C2B-C58E-38B4-7AEAD6DDCEB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13860" y="3529390"/>
            <a:ext cx="2028748" cy="1595164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1F4436A2-B4BD-C764-8F0F-7083F65483A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79675" y="175174"/>
            <a:ext cx="2151752" cy="165690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E777A571-D1AB-F201-89B7-7B4FABFCE42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619630" y="1832079"/>
            <a:ext cx="2116246" cy="157488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167837FD-714C-F0D6-57F6-2658D598E95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974458" y="3520833"/>
            <a:ext cx="2121713" cy="1612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34096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2173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5 (A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169016-D9DD-9B27-EFF4-8C11C35C3EEF}"/>
              </a:ext>
            </a:extLst>
          </p:cNvPr>
          <p:cNvSpPr txBox="1"/>
          <p:nvPr/>
        </p:nvSpPr>
        <p:spPr>
          <a:xfrm>
            <a:off x="80211" y="680491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dult FVB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154F56DB-5BBE-6EC7-6609-F3A7EB2138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0358" y="1821399"/>
            <a:ext cx="2131935" cy="160566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4543C2DB-0641-5040-A6C9-4474DFA39A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52328" y="179560"/>
            <a:ext cx="2274558" cy="165422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34E2A75-BEA7-B3D3-9802-E8711CAB10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59027" y="175176"/>
            <a:ext cx="2207789" cy="164630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71383D4F-7FD9-CEEA-3A45-4DBA81854D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2730" y="172173"/>
            <a:ext cx="2267685" cy="1649226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A3A8E9BE-B775-EEEE-2DC6-9A893D9230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59623" y="172173"/>
            <a:ext cx="2207789" cy="166141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81C83EA-1F62-E119-CE3C-C6974AA2C7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72115" y="1833591"/>
            <a:ext cx="2267685" cy="1649225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49DFD31E-6872-55EE-6C82-C8418438AE4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11143" y="1833591"/>
            <a:ext cx="2107453" cy="1640337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9D733925-AD29-23DE-5F90-D18844C145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582700" y="1821399"/>
            <a:ext cx="2208414" cy="1646769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273C7D5-047B-CD54-DE70-E4711291B52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25642" y="3482816"/>
            <a:ext cx="2274558" cy="164848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45A6295B-A30B-052E-0736-D6BD0CD4494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11143" y="3482816"/>
            <a:ext cx="2273024" cy="1649225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59FCEB6C-9852-280B-054E-7173F0D349B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582700" y="3475623"/>
            <a:ext cx="2255462" cy="1640336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32178A25-F8B2-DF65-61DF-F2306F74576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409194" y="5187049"/>
            <a:ext cx="2107453" cy="164033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4ACD859-2C39-5CC6-DF6F-593D7B928BA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82730" y="3535822"/>
            <a:ext cx="2131935" cy="16258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76249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2173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5 (B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169016-D9DD-9B27-EFF4-8C11C35C3EEF}"/>
              </a:ext>
            </a:extLst>
          </p:cNvPr>
          <p:cNvSpPr txBox="1"/>
          <p:nvPr/>
        </p:nvSpPr>
        <p:spPr>
          <a:xfrm>
            <a:off x="80211" y="680491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dult FV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FB3986-D0C7-B079-8933-E43073915E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9631" y="3591974"/>
            <a:ext cx="2161328" cy="156791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5B43F90-36AC-3660-07ED-42FFA4CF7D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69643" y="175175"/>
            <a:ext cx="2161328" cy="156791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4209E52-14D7-897B-BCEB-E448A3976D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1866" y="175175"/>
            <a:ext cx="2116687" cy="156791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BC8401C-4987-9DC0-C03E-6726DA2BBB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77580" y="175176"/>
            <a:ext cx="2116686" cy="153940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2E66C35-793F-3FC3-AC7A-9A971C0074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99631" y="175175"/>
            <a:ext cx="2161328" cy="157187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E9A980B-E621-41CD-0215-EDD069C9400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20241" y="1859685"/>
            <a:ext cx="2108891" cy="153373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08E64E8-5DA9-BF4C-FACD-B1546BB882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94331" y="1862654"/>
            <a:ext cx="2105092" cy="153097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2A6C089-7A14-FC95-D17E-638FBBD19DB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99630" y="1839199"/>
            <a:ext cx="2161330" cy="157187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698574B-00D2-5989-E554-C41A850864F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365348" y="1829058"/>
            <a:ext cx="2240914" cy="162975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75BB408-C51A-E8A2-45B9-DE7C715414C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20242" y="3591974"/>
            <a:ext cx="2112331" cy="156791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847B767-4B56-0AC2-0659-4C981792BBB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94330" y="3597746"/>
            <a:ext cx="2105093" cy="156254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B71CFDE-9BBA-3F46-777B-FB74D3B410A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416739" y="3591975"/>
            <a:ext cx="2145244" cy="159234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6F0575E-C727-2503-1A04-FBAB9C84E71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411866" y="5270393"/>
            <a:ext cx="2083839" cy="154676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FDB212E-AE94-F4CE-1D5A-641EA598584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720381" y="5179432"/>
            <a:ext cx="2157284" cy="1601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79969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20441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6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169016-D9DD-9B27-EFF4-8C11C35C3EEF}"/>
              </a:ext>
            </a:extLst>
          </p:cNvPr>
          <p:cNvSpPr txBox="1"/>
          <p:nvPr/>
        </p:nvSpPr>
        <p:spPr>
          <a:xfrm>
            <a:off x="80211" y="701635"/>
            <a:ext cx="15392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dolescent Wnt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927CD8A-9B82-32C2-8168-C53686B8C8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3897" y="175175"/>
            <a:ext cx="2130113" cy="15770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942CDBF-D794-2926-DAA1-60ED95EBCB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34010" y="175174"/>
            <a:ext cx="2130113" cy="15491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05FDD84-60DE-42F6-94EE-5EE7884032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38657" y="175174"/>
            <a:ext cx="2038670" cy="154917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71BD614-D5B8-37A5-32BF-4B7E0A72E3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8768" y="175174"/>
            <a:ext cx="2038670" cy="150934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DA9811C-5B53-49C9-9815-F8E39972737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03897" y="1752225"/>
            <a:ext cx="2038669" cy="150934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494163F-B324-F75B-31E4-B9E95319D4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35751" y="1750626"/>
            <a:ext cx="2133017" cy="158327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EC20EE1-6752-6555-D75F-186783902D1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68768" y="1694188"/>
            <a:ext cx="2184160" cy="162542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CFA75A6-92AC-D2AF-E49A-6A73B01A94F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34009" y="3442994"/>
            <a:ext cx="2146880" cy="162541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9FD9C9C8-32BD-EBBB-9396-A22EC1FB4E0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34009" y="1750626"/>
            <a:ext cx="2130113" cy="155217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4DF5E7D-4415-7B7C-BAB3-A4E91176E76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03897" y="3411951"/>
            <a:ext cx="2184160" cy="168750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BD48BEF-8FC7-81FD-9622-6D1E825B635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735751" y="3442994"/>
            <a:ext cx="2133241" cy="165918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971A355-2EE4-E78E-AD84-9E9AF12B01C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868768" y="3440637"/>
            <a:ext cx="2231329" cy="162777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8F23F2D-BE9E-CAA3-F62D-054E9E5E93B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303897" y="5099453"/>
            <a:ext cx="2145978" cy="170702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56EB0D3-BD83-0947-3695-759C759AFCD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434009" y="5092783"/>
            <a:ext cx="2316681" cy="172531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860A160-C67A-6681-3479-8266ED97ED1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773933" y="5063711"/>
            <a:ext cx="2213040" cy="172531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FB1DAA5-035D-EB3D-17C6-B358AF2426E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907174" y="5092783"/>
            <a:ext cx="2182557" cy="1658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96364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169016-D9DD-9B27-EFF4-8C11C35C3EEF}"/>
              </a:ext>
            </a:extLst>
          </p:cNvPr>
          <p:cNvSpPr txBox="1"/>
          <p:nvPr/>
        </p:nvSpPr>
        <p:spPr>
          <a:xfrm>
            <a:off x="80211" y="680491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dult Wnt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2A1A17F-8933-AD13-A55E-ED2785ACCB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1962" y="246898"/>
            <a:ext cx="2163704" cy="162824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0147A72-FC15-DB10-97B6-A68F015B9A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54497" y="267523"/>
            <a:ext cx="2163704" cy="157360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4FA9640-1AED-D752-1AE9-A1E99F26B5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25535" y="267523"/>
            <a:ext cx="2051958" cy="160633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19E31C9-DEE3-4321-56D0-198E7C4C7A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80347" y="269027"/>
            <a:ext cx="2160030" cy="160332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8D7C154-1C17-5D36-CD66-617D5EB67DC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79079" y="1875139"/>
            <a:ext cx="2014803" cy="172400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1845230-B6F0-C7B7-CBD7-FF3A81158F4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18591" y="1874283"/>
            <a:ext cx="2209883" cy="160718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2337DD3-93B1-E792-9B70-CE70577B5D6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89858" y="1872348"/>
            <a:ext cx="2208705" cy="160633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C52ED54-DD23-07D7-B4D2-1AE0BFC9E13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54108" y="3481471"/>
            <a:ext cx="2041529" cy="160332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4078FB63-CB43-8531-3EDB-D70820A8DEF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606813" y="3541725"/>
            <a:ext cx="2051148" cy="166267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ADB0D78-CB96-AC68-46A1-48EB4D8EE37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814196" y="3530184"/>
            <a:ext cx="2160030" cy="172911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7E60589-E1AF-C606-247E-ACA8DDAF18F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56445" y="1875140"/>
            <a:ext cx="2162146" cy="1655044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C1CAA8CD-AAA6-8B81-ABD8-74230748D80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261972" y="3481471"/>
            <a:ext cx="2041529" cy="160847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0760CDED-3162-167F-34B1-6F08E79DEF8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249455" y="5127620"/>
            <a:ext cx="2105994" cy="165926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7DFBB605-9620-2802-7942-E6D11AE1516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58561" y="5145047"/>
            <a:ext cx="2160030" cy="1641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19740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DF677C3-EB4D-52AF-571B-6E8B31E912A9}"/>
              </a:ext>
            </a:extLst>
          </p:cNvPr>
          <p:cNvSpPr txBox="1"/>
          <p:nvPr/>
        </p:nvSpPr>
        <p:spPr>
          <a:xfrm>
            <a:off x="80211" y="175175"/>
            <a:ext cx="19119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034E96F8-C793-AD8F-9126-81762227D4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0084154"/>
              </p:ext>
            </p:extLst>
          </p:nvPr>
        </p:nvGraphicFramePr>
        <p:xfrm>
          <a:off x="1745212" y="1246042"/>
          <a:ext cx="7706697" cy="4119060"/>
        </p:xfrm>
        <a:graphic>
          <a:graphicData uri="http://schemas.openxmlformats.org/drawingml/2006/table">
            <a:tbl>
              <a:tblPr/>
              <a:tblGrid>
                <a:gridCol w="2995866">
                  <a:extLst>
                    <a:ext uri="{9D8B030D-6E8A-4147-A177-3AD203B41FA5}">
                      <a16:colId xmlns:a16="http://schemas.microsoft.com/office/drawing/2014/main" val="3553802895"/>
                    </a:ext>
                  </a:extLst>
                </a:gridCol>
                <a:gridCol w="1072384">
                  <a:extLst>
                    <a:ext uri="{9D8B030D-6E8A-4147-A177-3AD203B41FA5}">
                      <a16:colId xmlns:a16="http://schemas.microsoft.com/office/drawing/2014/main" val="2693739568"/>
                    </a:ext>
                  </a:extLst>
                </a:gridCol>
                <a:gridCol w="817055">
                  <a:extLst>
                    <a:ext uri="{9D8B030D-6E8A-4147-A177-3AD203B41FA5}">
                      <a16:colId xmlns:a16="http://schemas.microsoft.com/office/drawing/2014/main" val="3902574383"/>
                    </a:ext>
                  </a:extLst>
                </a:gridCol>
                <a:gridCol w="817055">
                  <a:extLst>
                    <a:ext uri="{9D8B030D-6E8A-4147-A177-3AD203B41FA5}">
                      <a16:colId xmlns:a16="http://schemas.microsoft.com/office/drawing/2014/main" val="1766777382"/>
                    </a:ext>
                  </a:extLst>
                </a:gridCol>
                <a:gridCol w="995785">
                  <a:extLst>
                    <a:ext uri="{9D8B030D-6E8A-4147-A177-3AD203B41FA5}">
                      <a16:colId xmlns:a16="http://schemas.microsoft.com/office/drawing/2014/main" val="2394794714"/>
                    </a:ext>
                  </a:extLst>
                </a:gridCol>
                <a:gridCol w="1008552">
                  <a:extLst>
                    <a:ext uri="{9D8B030D-6E8A-4147-A177-3AD203B41FA5}">
                      <a16:colId xmlns:a16="http://schemas.microsoft.com/office/drawing/2014/main" val="1831154647"/>
                    </a:ext>
                  </a:extLst>
                </a:gridCol>
              </a:tblGrid>
              <a:tr h="37446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V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TV-Wnt1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796031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xon Nam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lesc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lesc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3575997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 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ecalibaculum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*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7288708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 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ricibacte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6449965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</a:t>
                      </a:r>
                      <a:r>
                        <a:rPr lang="en-US" sz="1200" b="0" i="1" u="none" strike="noStrike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. </a:t>
                      </a:r>
                      <a:r>
                        <a:rPr lang="en-US" sz="1200" b="0" i="1" u="none" strike="noStrike" dirty="0" err="1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ldsteini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274416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 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5962712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. 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iniphil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**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104482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</a:t>
                      </a:r>
                      <a:r>
                        <a:rPr lang="en-US" sz="1200" b="0" i="1" u="none" strike="noStrike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intestinalis</a:t>
                      </a:r>
                      <a:endParaRPr lang="en-US" sz="12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9069532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 </a:t>
                      </a:r>
                      <a:r>
                        <a:rPr lang="en-US" sz="1200" b="0" i="1" u="none" strike="noStrike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tus </a:t>
                      </a:r>
                      <a:r>
                        <a:rPr lang="en-US" sz="1200" b="0" i="1" u="none" strike="noStrike" dirty="0" err="1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ccharimonas</a:t>
                      </a:r>
                      <a:endParaRPr lang="en-US" sz="12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6091629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 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binix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6124861"/>
                  </a:ext>
                </a:extLst>
              </a:tr>
              <a:tr h="374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 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eroplasm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4351242"/>
                  </a:ext>
                </a:extLst>
              </a:tr>
            </a:tbl>
          </a:graphicData>
        </a:graphic>
      </p:graphicFrame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7C3DBE3-BF9C-64AF-76C1-92EC3B1CBD77}"/>
              </a:ext>
            </a:extLst>
          </p:cNvPr>
          <p:cNvCxnSpPr>
            <a:cxnSpLocks/>
          </p:cNvCxnSpPr>
          <p:nvPr/>
        </p:nvCxnSpPr>
        <p:spPr>
          <a:xfrm flipV="1">
            <a:off x="7410451" y="2552700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D0C2D2CA-98C7-3035-F9D9-B5497DA5C0CB}"/>
              </a:ext>
            </a:extLst>
          </p:cNvPr>
          <p:cNvCxnSpPr>
            <a:cxnSpLocks/>
          </p:cNvCxnSpPr>
          <p:nvPr/>
        </p:nvCxnSpPr>
        <p:spPr>
          <a:xfrm flipV="1">
            <a:off x="5783036" y="2925534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C8FFA38F-831A-0980-99A0-E4A9D8A839B6}"/>
              </a:ext>
            </a:extLst>
          </p:cNvPr>
          <p:cNvCxnSpPr>
            <a:cxnSpLocks/>
          </p:cNvCxnSpPr>
          <p:nvPr/>
        </p:nvCxnSpPr>
        <p:spPr>
          <a:xfrm flipV="1">
            <a:off x="4710794" y="3638549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E424FDF2-AE20-BFB7-A5B7-69E6F6575BF0}"/>
              </a:ext>
            </a:extLst>
          </p:cNvPr>
          <p:cNvCxnSpPr>
            <a:cxnSpLocks/>
          </p:cNvCxnSpPr>
          <p:nvPr/>
        </p:nvCxnSpPr>
        <p:spPr>
          <a:xfrm>
            <a:off x="7410451" y="4063093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23FB446-7977-BDBE-30EC-B03BA7F3F0F0}"/>
              </a:ext>
            </a:extLst>
          </p:cNvPr>
          <p:cNvCxnSpPr>
            <a:cxnSpLocks/>
          </p:cNvCxnSpPr>
          <p:nvPr/>
        </p:nvCxnSpPr>
        <p:spPr>
          <a:xfrm>
            <a:off x="5783036" y="4435927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9338051A-EDC5-8733-79E3-2A3908CC1F2C}"/>
              </a:ext>
            </a:extLst>
          </p:cNvPr>
          <p:cNvCxnSpPr>
            <a:cxnSpLocks/>
          </p:cNvCxnSpPr>
          <p:nvPr/>
        </p:nvCxnSpPr>
        <p:spPr>
          <a:xfrm>
            <a:off x="7421337" y="4425041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FC23A5E-3377-70E3-6353-800A7B293802}"/>
              </a:ext>
            </a:extLst>
          </p:cNvPr>
          <p:cNvCxnSpPr>
            <a:cxnSpLocks/>
          </p:cNvCxnSpPr>
          <p:nvPr/>
        </p:nvCxnSpPr>
        <p:spPr>
          <a:xfrm>
            <a:off x="7418616" y="4814206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6EE85A77-6FAA-F556-9331-0C116523C84F}"/>
              </a:ext>
            </a:extLst>
          </p:cNvPr>
          <p:cNvCxnSpPr>
            <a:cxnSpLocks/>
          </p:cNvCxnSpPr>
          <p:nvPr/>
        </p:nvCxnSpPr>
        <p:spPr>
          <a:xfrm>
            <a:off x="8411936" y="4819648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E6BDB49-3C4B-4496-ACB6-1C1D45FCE8C7}"/>
              </a:ext>
            </a:extLst>
          </p:cNvPr>
          <p:cNvCxnSpPr>
            <a:cxnSpLocks/>
          </p:cNvCxnSpPr>
          <p:nvPr/>
        </p:nvCxnSpPr>
        <p:spPr>
          <a:xfrm>
            <a:off x="4710789" y="4825091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72351CD-6AF0-C6DF-0D23-449D38E2B062}"/>
              </a:ext>
            </a:extLst>
          </p:cNvPr>
          <p:cNvCxnSpPr>
            <a:cxnSpLocks/>
          </p:cNvCxnSpPr>
          <p:nvPr/>
        </p:nvCxnSpPr>
        <p:spPr>
          <a:xfrm>
            <a:off x="4708067" y="5189762"/>
            <a:ext cx="0" cy="206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5A1ED614-CD05-0AB5-6B29-C990A127B49C}"/>
              </a:ext>
            </a:extLst>
          </p:cNvPr>
          <p:cNvCxnSpPr>
            <a:cxnSpLocks/>
          </p:cNvCxnSpPr>
          <p:nvPr/>
        </p:nvCxnSpPr>
        <p:spPr>
          <a:xfrm flipV="1">
            <a:off x="8411936" y="2925534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1884E8AC-3A05-20C0-BD6B-16CD7AC3C15A}"/>
              </a:ext>
            </a:extLst>
          </p:cNvPr>
          <p:cNvCxnSpPr>
            <a:cxnSpLocks/>
          </p:cNvCxnSpPr>
          <p:nvPr/>
        </p:nvCxnSpPr>
        <p:spPr>
          <a:xfrm flipV="1">
            <a:off x="7410452" y="2158093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08BEAB69-666D-D6C8-6BCF-1EBF036DBD7D}"/>
              </a:ext>
            </a:extLst>
          </p:cNvPr>
          <p:cNvCxnSpPr>
            <a:cxnSpLocks/>
          </p:cNvCxnSpPr>
          <p:nvPr/>
        </p:nvCxnSpPr>
        <p:spPr>
          <a:xfrm flipV="1">
            <a:off x="5780314" y="3273877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E1BDDA26-8DF0-0696-250A-51CC23BF4912}"/>
              </a:ext>
            </a:extLst>
          </p:cNvPr>
          <p:cNvCxnSpPr>
            <a:cxnSpLocks/>
          </p:cNvCxnSpPr>
          <p:nvPr/>
        </p:nvCxnSpPr>
        <p:spPr>
          <a:xfrm flipV="1">
            <a:off x="8406497" y="3262993"/>
            <a:ext cx="0" cy="19594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9632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0</TotalTime>
  <Words>143</Words>
  <Application>Microsoft Office PowerPoint</Application>
  <PresentationFormat>Widescreen</PresentationFormat>
  <Paragraphs>74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Hui</dc:creator>
  <cp:lastModifiedBy>Li, Hui</cp:lastModifiedBy>
  <cp:revision>131</cp:revision>
  <cp:lastPrinted>2024-10-28T15:01:47Z</cp:lastPrinted>
  <dcterms:created xsi:type="dcterms:W3CDTF">2024-09-10T19:03:15Z</dcterms:created>
  <dcterms:modified xsi:type="dcterms:W3CDTF">2025-06-16T19:29:24Z</dcterms:modified>
</cp:coreProperties>
</file>